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charts/chart2.xml" ContentType="application/vnd.openxmlformats-officedocument.drawingml.char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charts/chart1.xml" ContentType="application/vnd.openxmlformats-officedocument.drawingml.char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62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 horzBarState="maximized">
    <p:restoredLeft sz="15620"/>
    <p:restoredTop sz="94484" autoAdjust="0"/>
  </p:normalViewPr>
  <p:slideViewPr>
    <p:cSldViewPr snapToGrid="0" snapToObjects="1">
      <p:cViewPr>
        <p:scale>
          <a:sx n="112" d="100"/>
          <a:sy n="112" d="100"/>
        </p:scale>
        <p:origin x="-305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Applications:Microsoft%20Office%202011:Office:Add-Ins:Statcel2.xla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aeda:Desktop:desktop:&#25925;&#38556;&#26178;&#20445;&#31649;&#22580;&#25152;:citrulline:&#35542;&#25991;:&#12304;&#20351;&#29992;&#12305;BW&#12539;Glu&#12487;&#12540;&#1247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8"/>
  <c:chart>
    <c:plotArea>
      <c:layout>
        <c:manualLayout>
          <c:layoutTarget val="inner"/>
          <c:xMode val="edge"/>
          <c:yMode val="edge"/>
          <c:x val="0.134115024673372"/>
          <c:y val="0.0216606498194946"/>
          <c:w val="0.762097520409478"/>
          <c:h val="0.861564569771739"/>
        </c:manualLayout>
      </c:layout>
      <c:lineChart>
        <c:grouping val="standard"/>
        <c:ser>
          <c:idx val="0"/>
          <c:order val="0"/>
          <c:tx>
            <c:strRef>
              <c:f>'[1]血糖値 '!$Q$4</c:f>
              <c:strCache>
                <c:ptCount val="1"/>
                <c:pt idx="0">
                  <c:v>Cont.</c:v>
                </c:pt>
              </c:strCache>
            </c:strRef>
          </c:tx>
          <c:spPr>
            <a:ln w="25400">
              <a:solidFill>
                <a:schemeClr val="tx1"/>
              </a:solidFill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plus>
              <c:numRef>
                <c:f>'[1]血糖値 '!$R$11:$V$11</c:f>
                <c:numCache>
                  <c:formatCode>General</c:formatCode>
                  <c:ptCount val="5"/>
                  <c:pt idx="0">
                    <c:v>27.9</c:v>
                  </c:pt>
                  <c:pt idx="1">
                    <c:v>36.8</c:v>
                  </c:pt>
                  <c:pt idx="2">
                    <c:v>33.3</c:v>
                  </c:pt>
                  <c:pt idx="3">
                    <c:v>63.3</c:v>
                  </c:pt>
                  <c:pt idx="4">
                    <c:v>94.0</c:v>
                  </c:pt>
                </c:numCache>
              </c:numRef>
            </c:plus>
            <c:minus>
              <c:numRef>
                <c:f>'[1]血糖値 '!$R$11:$V$11</c:f>
                <c:numCache>
                  <c:formatCode>General</c:formatCode>
                  <c:ptCount val="5"/>
                  <c:pt idx="0">
                    <c:v>27.9</c:v>
                  </c:pt>
                  <c:pt idx="1">
                    <c:v>36.8</c:v>
                  </c:pt>
                  <c:pt idx="2">
                    <c:v>33.3</c:v>
                  </c:pt>
                  <c:pt idx="3">
                    <c:v>63.3</c:v>
                  </c:pt>
                  <c:pt idx="4">
                    <c:v>94.0</c:v>
                  </c:pt>
                </c:numCache>
              </c:numRef>
            </c:minus>
          </c:errBars>
          <c:cat>
            <c:strRef>
              <c:f>'[1]血糖値 '!$R$3:$V$3</c:f>
              <c:strCache>
                <c:ptCount val="5"/>
                <c:pt idx="0">
                  <c:v>_x0002_0w</c:v>
                </c:pt>
                <c:pt idx="1">
                  <c:v>_x0002_1w</c:v>
                </c:pt>
                <c:pt idx="2">
                  <c:v>_x0002_2w</c:v>
                </c:pt>
                <c:pt idx="3">
                  <c:v>_x0002_3w</c:v>
                </c:pt>
                <c:pt idx="4">
                  <c:v>_x0002_4w</c:v>
                </c:pt>
              </c:strCache>
            </c:strRef>
          </c:cat>
          <c:val>
            <c:numRef>
              <c:f>'[1]血糖値 '!$R$4:$V$4</c:f>
              <c:numCache>
                <c:formatCode>General</c:formatCode>
                <c:ptCount val="5"/>
                <c:pt idx="0">
                  <c:v>150.5</c:v>
                </c:pt>
                <c:pt idx="1">
                  <c:v>295.5</c:v>
                </c:pt>
                <c:pt idx="2">
                  <c:v>449.1666666666666</c:v>
                </c:pt>
                <c:pt idx="3">
                  <c:v>612.5</c:v>
                </c:pt>
                <c:pt idx="4">
                  <c:v>605.5</c:v>
                </c:pt>
              </c:numCache>
            </c:numRef>
          </c:val>
        </c:ser>
        <c:ser>
          <c:idx val="1"/>
          <c:order val="1"/>
          <c:tx>
            <c:strRef>
              <c:f>'[1]血糖値 '!$Q$5</c:f>
              <c:strCache>
                <c:ptCount val="1"/>
                <c:pt idx="0">
                  <c:v>Arg</c:v>
                </c:pt>
              </c:strCache>
            </c:strRef>
          </c:tx>
          <c:spPr>
            <a:ln w="25400">
              <a:solidFill>
                <a:schemeClr val="tx1"/>
              </a:solidFill>
            </a:ln>
            <a:effectLst/>
          </c:spPr>
          <c:marker>
            <c:symbol val="squar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plus>
              <c:numRef>
                <c:f>'[1]血糖値 '!$R$12:$V$12</c:f>
                <c:numCache>
                  <c:formatCode>General</c:formatCode>
                  <c:ptCount val="5"/>
                  <c:pt idx="0">
                    <c:v>14.8</c:v>
                  </c:pt>
                  <c:pt idx="1">
                    <c:v>28.4</c:v>
                  </c:pt>
                  <c:pt idx="2">
                    <c:v>67.0</c:v>
                  </c:pt>
                  <c:pt idx="3">
                    <c:v>37.1</c:v>
                  </c:pt>
                  <c:pt idx="4">
                    <c:v>42.1</c:v>
                  </c:pt>
                </c:numCache>
              </c:numRef>
            </c:plus>
            <c:minus>
              <c:numRef>
                <c:f>'[1]血糖値 '!$R$12:$V$12</c:f>
                <c:numCache>
                  <c:formatCode>General</c:formatCode>
                  <c:ptCount val="5"/>
                  <c:pt idx="0">
                    <c:v>14.8</c:v>
                  </c:pt>
                  <c:pt idx="1">
                    <c:v>28.4</c:v>
                  </c:pt>
                  <c:pt idx="2">
                    <c:v>67.0</c:v>
                  </c:pt>
                  <c:pt idx="3">
                    <c:v>37.1</c:v>
                  </c:pt>
                  <c:pt idx="4">
                    <c:v>42.1</c:v>
                  </c:pt>
                </c:numCache>
              </c:numRef>
            </c:minus>
          </c:errBars>
          <c:cat>
            <c:strRef>
              <c:f>'[1]血糖値 '!$R$3:$V$3</c:f>
              <c:strCache>
                <c:ptCount val="5"/>
                <c:pt idx="0">
                  <c:v>_x0002_0w</c:v>
                </c:pt>
                <c:pt idx="1">
                  <c:v>_x0002_1w</c:v>
                </c:pt>
                <c:pt idx="2">
                  <c:v>_x0002_2w</c:v>
                </c:pt>
                <c:pt idx="3">
                  <c:v>_x0002_3w</c:v>
                </c:pt>
                <c:pt idx="4">
                  <c:v>_x0002_4w</c:v>
                </c:pt>
              </c:strCache>
            </c:strRef>
          </c:cat>
          <c:val>
            <c:numRef>
              <c:f>'[1]血糖値 '!$R$5:$V$5</c:f>
              <c:numCache>
                <c:formatCode>General</c:formatCode>
                <c:ptCount val="5"/>
                <c:pt idx="0">
                  <c:v>152.1666666666667</c:v>
                </c:pt>
                <c:pt idx="1">
                  <c:v>242.0</c:v>
                </c:pt>
                <c:pt idx="2">
                  <c:v>545.6666666666666</c:v>
                </c:pt>
                <c:pt idx="3">
                  <c:v>545.0</c:v>
                </c:pt>
                <c:pt idx="4">
                  <c:v>561.8333333333333</c:v>
                </c:pt>
              </c:numCache>
            </c:numRef>
          </c:val>
        </c:ser>
        <c:ser>
          <c:idx val="2"/>
          <c:order val="2"/>
          <c:tx>
            <c:strRef>
              <c:f>'[1]血糖値 '!$Q$6</c:f>
              <c:strCache>
                <c:ptCount val="1"/>
                <c:pt idx="0">
                  <c:v>Cit</c:v>
                </c:pt>
              </c:strCache>
            </c:strRef>
          </c:tx>
          <c:spPr>
            <a:ln w="25400">
              <a:solidFill>
                <a:schemeClr val="tx1"/>
              </a:solidFill>
            </a:ln>
            <a:effectLst/>
          </c:spPr>
          <c:marker>
            <c:symbol val="triangle"/>
            <c:size val="11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plus>
              <c:numRef>
                <c:f>'[1]血糖値 '!$R$13:$V$13</c:f>
                <c:numCache>
                  <c:formatCode>General</c:formatCode>
                  <c:ptCount val="5"/>
                  <c:pt idx="0">
                    <c:v>8.7</c:v>
                  </c:pt>
                  <c:pt idx="1">
                    <c:v>39.4</c:v>
                  </c:pt>
                  <c:pt idx="2">
                    <c:v>27.9</c:v>
                  </c:pt>
                  <c:pt idx="3">
                    <c:v>39.6</c:v>
                  </c:pt>
                  <c:pt idx="4">
                    <c:v>17.1</c:v>
                  </c:pt>
                </c:numCache>
              </c:numRef>
            </c:plus>
            <c:minus>
              <c:numRef>
                <c:f>'[1]血糖値 '!$R$13:$V$13</c:f>
                <c:numCache>
                  <c:formatCode>General</c:formatCode>
                  <c:ptCount val="5"/>
                  <c:pt idx="0">
                    <c:v>8.7</c:v>
                  </c:pt>
                  <c:pt idx="1">
                    <c:v>39.4</c:v>
                  </c:pt>
                  <c:pt idx="2">
                    <c:v>27.9</c:v>
                  </c:pt>
                  <c:pt idx="3">
                    <c:v>39.6</c:v>
                  </c:pt>
                  <c:pt idx="4">
                    <c:v>17.1</c:v>
                  </c:pt>
                </c:numCache>
              </c:numRef>
            </c:minus>
          </c:errBars>
          <c:cat>
            <c:strRef>
              <c:f>'[1]血糖値 '!$R$3:$V$3</c:f>
              <c:strCache>
                <c:ptCount val="5"/>
                <c:pt idx="0">
                  <c:v>_x0002_0w</c:v>
                </c:pt>
                <c:pt idx="1">
                  <c:v>_x0002_1w</c:v>
                </c:pt>
                <c:pt idx="2">
                  <c:v>_x0002_2w</c:v>
                </c:pt>
                <c:pt idx="3">
                  <c:v>_x0002_3w</c:v>
                </c:pt>
                <c:pt idx="4">
                  <c:v>_x0002_4w</c:v>
                </c:pt>
              </c:strCache>
            </c:strRef>
          </c:cat>
          <c:val>
            <c:numRef>
              <c:f>'[1]血糖値 '!$R$6:$V$6</c:f>
              <c:numCache>
                <c:formatCode>General</c:formatCode>
                <c:ptCount val="5"/>
                <c:pt idx="0">
                  <c:v>151.3333333333333</c:v>
                </c:pt>
                <c:pt idx="1">
                  <c:v>284.5</c:v>
                </c:pt>
                <c:pt idx="2">
                  <c:v>427.5</c:v>
                </c:pt>
                <c:pt idx="3">
                  <c:v>542.3333333333333</c:v>
                </c:pt>
                <c:pt idx="4">
                  <c:v>452.1666666666666</c:v>
                </c:pt>
              </c:numCache>
            </c:numRef>
          </c:val>
        </c:ser>
        <c:ser>
          <c:idx val="3"/>
          <c:order val="3"/>
          <c:tx>
            <c:strRef>
              <c:f>'[1]血糖値 '!$Q$7</c:f>
              <c:strCache>
                <c:ptCount val="1"/>
                <c:pt idx="0">
                  <c:v>Arg+Cit</c:v>
                </c:pt>
              </c:strCache>
            </c:strRef>
          </c:tx>
          <c:spPr>
            <a:ln w="25400">
              <a:solidFill>
                <a:schemeClr val="tx1"/>
              </a:solidFill>
            </a:ln>
            <a:effectLst/>
          </c:spPr>
          <c:marker>
            <c:symbol val="diamond"/>
            <c:size val="11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plus>
              <c:numRef>
                <c:f>'[1]血糖値 '!$R$14:$V$14</c:f>
                <c:numCache>
                  <c:formatCode>General</c:formatCode>
                  <c:ptCount val="5"/>
                  <c:pt idx="0">
                    <c:v>22.7</c:v>
                  </c:pt>
                  <c:pt idx="1">
                    <c:v>44.6</c:v>
                  </c:pt>
                  <c:pt idx="2">
                    <c:v>105.0</c:v>
                  </c:pt>
                  <c:pt idx="3">
                    <c:v>108.5</c:v>
                  </c:pt>
                  <c:pt idx="4">
                    <c:v>127.3</c:v>
                  </c:pt>
                </c:numCache>
              </c:numRef>
            </c:plus>
            <c:minus>
              <c:numRef>
                <c:f>'[1]血糖値 '!$R$14:$V$14</c:f>
                <c:numCache>
                  <c:formatCode>General</c:formatCode>
                  <c:ptCount val="5"/>
                  <c:pt idx="0">
                    <c:v>22.7</c:v>
                  </c:pt>
                  <c:pt idx="1">
                    <c:v>44.6</c:v>
                  </c:pt>
                  <c:pt idx="2">
                    <c:v>105.0</c:v>
                  </c:pt>
                  <c:pt idx="3">
                    <c:v>108.5</c:v>
                  </c:pt>
                  <c:pt idx="4">
                    <c:v>127.3</c:v>
                  </c:pt>
                </c:numCache>
              </c:numRef>
            </c:minus>
          </c:errBars>
          <c:cat>
            <c:strRef>
              <c:f>'[1]血糖値 '!$R$3:$V$3</c:f>
              <c:strCache>
                <c:ptCount val="5"/>
                <c:pt idx="0">
                  <c:v>_x0002_0w</c:v>
                </c:pt>
                <c:pt idx="1">
                  <c:v>_x0002_1w</c:v>
                </c:pt>
                <c:pt idx="2">
                  <c:v>_x0002_2w</c:v>
                </c:pt>
                <c:pt idx="3">
                  <c:v>_x0002_3w</c:v>
                </c:pt>
                <c:pt idx="4">
                  <c:v>_x0002_4w</c:v>
                </c:pt>
              </c:strCache>
            </c:strRef>
          </c:cat>
          <c:val>
            <c:numRef>
              <c:f>'[1]血糖値 '!$R$7:$V$7</c:f>
              <c:numCache>
                <c:formatCode>General</c:formatCode>
                <c:ptCount val="5"/>
                <c:pt idx="0">
                  <c:v>155.8333333333333</c:v>
                </c:pt>
                <c:pt idx="1">
                  <c:v>275.8333333333333</c:v>
                </c:pt>
                <c:pt idx="2">
                  <c:v>499.3333333333333</c:v>
                </c:pt>
                <c:pt idx="3">
                  <c:v>664.1666666666666</c:v>
                </c:pt>
                <c:pt idx="4">
                  <c:v>682.0</c:v>
                </c:pt>
              </c:numCache>
            </c:numRef>
          </c:val>
        </c:ser>
        <c:marker val="1"/>
        <c:axId val="290387928"/>
        <c:axId val="301067528"/>
      </c:lineChart>
      <c:catAx>
        <c:axId val="290387928"/>
        <c:scaling>
          <c:orientation val="minMax"/>
        </c:scaling>
        <c:axPos val="b"/>
        <c:tickLblPos val="nextTo"/>
        <c:crossAx val="301067528"/>
        <c:crosses val="autoZero"/>
        <c:auto val="1"/>
        <c:lblAlgn val="ctr"/>
        <c:lblOffset val="100"/>
      </c:catAx>
      <c:valAx>
        <c:axId val="30106752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lood glucose level (mg/dL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00990520776177334"/>
              <c:y val="0.185014797444578"/>
            </c:manualLayout>
          </c:layout>
        </c:title>
        <c:numFmt formatCode="General" sourceLinked="1"/>
        <c:tickLblPos val="nextTo"/>
        <c:crossAx val="29038792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32244338870398"/>
          <c:y val="0.544053903614812"/>
          <c:w val="0.214787897609925"/>
          <c:h val="0.334671091798255"/>
        </c:manualLayout>
      </c:layout>
      <c:spPr>
        <a:solidFill>
          <a:schemeClr val="bg1"/>
        </a:solidFill>
        <a:ln>
          <a:solidFill>
            <a:schemeClr val="tx1"/>
          </a:solidFill>
        </a:ln>
      </c:spPr>
    </c:legend>
    <c:plotVisOnly val="1"/>
    <c:dispBlanksAs val="gap"/>
  </c:chart>
  <c:txPr>
    <a:bodyPr/>
    <a:lstStyle/>
    <a:p>
      <a:pPr>
        <a:defRPr>
          <a:latin typeface="Arial"/>
          <a:cs typeface="Arial"/>
        </a:defRPr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8"/>
  <c:chart>
    <c:plotArea>
      <c:layout>
        <c:manualLayout>
          <c:layoutTarget val="inner"/>
          <c:xMode val="edge"/>
          <c:yMode val="edge"/>
          <c:x val="0.132351253686573"/>
          <c:y val="0.0212071778140294"/>
          <c:w val="0.803033609469838"/>
          <c:h val="0.818079550717925"/>
        </c:manualLayout>
      </c:layout>
      <c:lineChart>
        <c:grouping val="standard"/>
        <c:ser>
          <c:idx val="0"/>
          <c:order val="0"/>
          <c:tx>
            <c:strRef>
              <c:f>体重!$Q$4</c:f>
              <c:strCache>
                <c:ptCount val="1"/>
                <c:pt idx="0">
                  <c:v>Cont.</c:v>
                </c:pt>
              </c:strCache>
            </c:strRef>
          </c:tx>
          <c:spPr>
            <a:ln w="25400">
              <a:solidFill>
                <a:schemeClr val="tx1"/>
              </a:solidFill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>
                <a:noFill/>
              </a:ln>
              <a:effectLst/>
            </c:spPr>
          </c:marker>
          <c:errBars>
            <c:errDir val="y"/>
            <c:errBarType val="plus"/>
            <c:errValType val="cust"/>
            <c:plus>
              <c:numRef>
                <c:f>体重!$R$12:$V$12</c:f>
                <c:numCache>
                  <c:formatCode>General</c:formatCode>
                  <c:ptCount val="5"/>
                  <c:pt idx="0">
                    <c:v>6.3</c:v>
                  </c:pt>
                  <c:pt idx="1">
                    <c:v>5.9</c:v>
                  </c:pt>
                  <c:pt idx="2">
                    <c:v>3.6</c:v>
                  </c:pt>
                  <c:pt idx="3">
                    <c:v>3.8</c:v>
                  </c:pt>
                  <c:pt idx="4">
                    <c:v>4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体重!$R$2:$V$3</c:f>
              <c:strCache>
                <c:ptCount val="5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</c:strCache>
            </c:strRef>
          </c:cat>
          <c:val>
            <c:numRef>
              <c:f>体重!$R$4:$V$4</c:f>
              <c:numCache>
                <c:formatCode>General</c:formatCode>
                <c:ptCount val="5"/>
                <c:pt idx="0">
                  <c:v>235.1666666666667</c:v>
                </c:pt>
                <c:pt idx="1">
                  <c:v>278.5</c:v>
                </c:pt>
                <c:pt idx="2">
                  <c:v>316.8333333333333</c:v>
                </c:pt>
                <c:pt idx="3">
                  <c:v>337.8333333333333</c:v>
                </c:pt>
                <c:pt idx="4">
                  <c:v>343.3333333333333</c:v>
                </c:pt>
              </c:numCache>
            </c:numRef>
          </c:val>
        </c:ser>
        <c:ser>
          <c:idx val="1"/>
          <c:order val="1"/>
          <c:tx>
            <c:strRef>
              <c:f>体重!$Q$5</c:f>
              <c:strCache>
                <c:ptCount val="1"/>
                <c:pt idx="0">
                  <c:v>Arg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square"/>
            <c:size val="9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plus"/>
            <c:errValType val="cust"/>
            <c:plus>
              <c:numRef>
                <c:f>体重!$R$13:$V$13</c:f>
                <c:numCache>
                  <c:formatCode>General</c:formatCode>
                  <c:ptCount val="5"/>
                  <c:pt idx="0">
                    <c:v>9.4</c:v>
                  </c:pt>
                  <c:pt idx="1">
                    <c:v>9.4</c:v>
                  </c:pt>
                  <c:pt idx="2">
                    <c:v>6.4</c:v>
                  </c:pt>
                  <c:pt idx="3">
                    <c:v>7.3</c:v>
                  </c:pt>
                  <c:pt idx="4">
                    <c:v>7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体重!$R$2:$V$3</c:f>
              <c:strCache>
                <c:ptCount val="5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</c:strCache>
            </c:strRef>
          </c:cat>
          <c:val>
            <c:numRef>
              <c:f>体重!$R$5:$V$5</c:f>
              <c:numCache>
                <c:formatCode>General</c:formatCode>
                <c:ptCount val="5"/>
                <c:pt idx="0">
                  <c:v>236.5</c:v>
                </c:pt>
                <c:pt idx="1">
                  <c:v>275.8333333333333</c:v>
                </c:pt>
                <c:pt idx="2">
                  <c:v>306.1666666666666</c:v>
                </c:pt>
                <c:pt idx="3">
                  <c:v>328.1666666666666</c:v>
                </c:pt>
                <c:pt idx="4">
                  <c:v>329.0</c:v>
                </c:pt>
              </c:numCache>
            </c:numRef>
          </c:val>
        </c:ser>
        <c:ser>
          <c:idx val="2"/>
          <c:order val="2"/>
          <c:tx>
            <c:strRef>
              <c:f>体重!$Q$6</c:f>
              <c:strCache>
                <c:ptCount val="1"/>
                <c:pt idx="0">
                  <c:v>Cit.</c:v>
                </c:pt>
              </c:strCache>
            </c:strRef>
          </c:tx>
          <c:spPr>
            <a:ln w="25400">
              <a:solidFill>
                <a:schemeClr val="tx1"/>
              </a:solidFill>
            </a:ln>
            <a:effectLst/>
          </c:spPr>
          <c:marker>
            <c:symbol val="triangle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plus>
              <c:numRef>
                <c:f>体重!$R$14:$V$14</c:f>
                <c:numCache>
                  <c:formatCode>General</c:formatCode>
                  <c:ptCount val="5"/>
                  <c:pt idx="0">
                    <c:v>7.4</c:v>
                  </c:pt>
                  <c:pt idx="1">
                    <c:v>7.8</c:v>
                  </c:pt>
                  <c:pt idx="2">
                    <c:v>5.7</c:v>
                  </c:pt>
                  <c:pt idx="3">
                    <c:v>5.3</c:v>
                  </c:pt>
                  <c:pt idx="4">
                    <c:v>5.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体重!$R$2:$V$3</c:f>
              <c:strCache>
                <c:ptCount val="5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</c:strCache>
            </c:strRef>
          </c:cat>
          <c:val>
            <c:numRef>
              <c:f>体重!$R$6:$V$6</c:f>
              <c:numCache>
                <c:formatCode>General</c:formatCode>
                <c:ptCount val="5"/>
                <c:pt idx="0">
                  <c:v>230.5</c:v>
                </c:pt>
                <c:pt idx="1">
                  <c:v>271.6666666666666</c:v>
                </c:pt>
                <c:pt idx="2">
                  <c:v>308.8333333333333</c:v>
                </c:pt>
                <c:pt idx="3">
                  <c:v>327.3333333333333</c:v>
                </c:pt>
                <c:pt idx="4">
                  <c:v>340.0</c:v>
                </c:pt>
              </c:numCache>
            </c:numRef>
          </c:val>
        </c:ser>
        <c:ser>
          <c:idx val="3"/>
          <c:order val="3"/>
          <c:tx>
            <c:strRef>
              <c:f>体重!$Q$7</c:f>
              <c:strCache>
                <c:ptCount val="1"/>
                <c:pt idx="0">
                  <c:v>Arg+Cit</c:v>
                </c:pt>
              </c:strCache>
            </c:strRef>
          </c:tx>
          <c:spPr>
            <a:ln w="25400">
              <a:solidFill>
                <a:schemeClr val="tx1"/>
              </a:solidFill>
            </a:ln>
            <a:effectLst/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plus>
              <c:numRef>
                <c:f>体重!$R$15:$V$15</c:f>
                <c:numCache>
                  <c:formatCode>General</c:formatCode>
                  <c:ptCount val="5"/>
                  <c:pt idx="0">
                    <c:v>7.0</c:v>
                  </c:pt>
                  <c:pt idx="1">
                    <c:v>9.0</c:v>
                  </c:pt>
                  <c:pt idx="2">
                    <c:v>6.0</c:v>
                  </c:pt>
                  <c:pt idx="3">
                    <c:v>5.5</c:v>
                  </c:pt>
                  <c:pt idx="4">
                    <c:v>4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体重!$R$2:$V$3</c:f>
              <c:strCache>
                <c:ptCount val="5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</c:strCache>
            </c:strRef>
          </c:cat>
          <c:val>
            <c:numRef>
              <c:f>体重!$R$7:$V$7</c:f>
              <c:numCache>
                <c:formatCode>General</c:formatCode>
                <c:ptCount val="5"/>
                <c:pt idx="0">
                  <c:v>243.3333333333333</c:v>
                </c:pt>
                <c:pt idx="1">
                  <c:v>281.3333333333333</c:v>
                </c:pt>
                <c:pt idx="2">
                  <c:v>311.8333333333333</c:v>
                </c:pt>
                <c:pt idx="3">
                  <c:v>327.1666666666666</c:v>
                </c:pt>
                <c:pt idx="4">
                  <c:v>325.1666666666666</c:v>
                </c:pt>
              </c:numCache>
            </c:numRef>
          </c:val>
        </c:ser>
        <c:marker val="1"/>
        <c:axId val="301526968"/>
        <c:axId val="301530024"/>
      </c:lineChart>
      <c:catAx>
        <c:axId val="301526968"/>
        <c:scaling>
          <c:orientation val="minMax"/>
        </c:scaling>
        <c:axPos val="b"/>
        <c:tickLblPos val="nextTo"/>
        <c:crossAx val="301530024"/>
        <c:crosses val="autoZero"/>
        <c:auto val="1"/>
        <c:lblAlgn val="ctr"/>
        <c:lblOffset val="100"/>
      </c:catAx>
      <c:valAx>
        <c:axId val="30153002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ody weight (g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0"/>
              <c:y val="0.253338725260569"/>
            </c:manualLayout>
          </c:layout>
        </c:title>
        <c:numFmt formatCode="General" sourceLinked="1"/>
        <c:tickLblPos val="nextTo"/>
        <c:crossAx val="3015269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42225243017261"/>
          <c:y val="0.40323558360352"/>
          <c:w val="0.230078009401391"/>
          <c:h val="0.295336961556276"/>
        </c:manualLayout>
      </c:layout>
      <c:spPr>
        <a:solidFill>
          <a:srgbClr val="FFFFFF"/>
        </a:solidFill>
        <a:ln>
          <a:solidFill>
            <a:srgbClr val="000000"/>
          </a:solidFill>
        </a:ln>
      </c:spPr>
    </c:legend>
    <c:plotVisOnly val="1"/>
    <c:dispBlanksAs val="gap"/>
  </c:chart>
  <c:txPr>
    <a:bodyPr/>
    <a:lstStyle/>
    <a:p>
      <a:pPr>
        <a:defRPr>
          <a:latin typeface="Arial"/>
          <a:cs typeface="Arial"/>
        </a:defRPr>
      </a:pPr>
      <a:endParaRPr lang="ja-JP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291715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9286889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199066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099250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562715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440594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801461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18752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446618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060881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935754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A3721-22EB-D04C-B728-D1B85A39B9E8}" type="datetimeFigureOut">
              <a:rPr kumimoji="1" lang="ja-JP" altLang="en-US" smtClean="0"/>
              <a:pPr/>
              <a:t>18.1.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FF897-D559-3449-840E-D910F0D5B1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57409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143624419"/>
              </p:ext>
            </p:extLst>
          </p:nvPr>
        </p:nvGraphicFramePr>
        <p:xfrm>
          <a:off x="910046" y="6227608"/>
          <a:ext cx="5293599" cy="2583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440101" y="363314"/>
            <a:ext cx="886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Arial"/>
                <a:cs typeface="Arial"/>
              </a:rPr>
              <a:t>S1 Fig</a:t>
            </a:r>
            <a:endParaRPr kumimoji="1" lang="ja-JP" altLang="en-US" dirty="0">
              <a:latin typeface="Arial"/>
              <a:cs typeface="Arial"/>
            </a:endParaRPr>
          </a:p>
        </p:txBody>
      </p:sp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0010261"/>
              </p:ext>
            </p:extLst>
          </p:nvPr>
        </p:nvGraphicFramePr>
        <p:xfrm>
          <a:off x="910046" y="2962930"/>
          <a:ext cx="4967350" cy="29131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956460" y="2430170"/>
            <a:ext cx="564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A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956460" y="5883428"/>
            <a:ext cx="564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B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grpSp>
        <p:nvGrpSpPr>
          <p:cNvPr id="12" name="図形グループ 11"/>
          <p:cNvGrpSpPr/>
          <p:nvPr/>
        </p:nvGrpSpPr>
        <p:grpSpPr>
          <a:xfrm>
            <a:off x="4118285" y="4123163"/>
            <a:ext cx="1137561" cy="895780"/>
            <a:chOff x="4118285" y="4123163"/>
            <a:chExt cx="1137561" cy="895780"/>
          </a:xfrm>
        </p:grpSpPr>
        <p:sp>
          <p:nvSpPr>
            <p:cNvPr id="2" name="テキスト ボックス 1"/>
            <p:cNvSpPr txBox="1"/>
            <p:nvPr/>
          </p:nvSpPr>
          <p:spPr>
            <a:xfrm>
              <a:off x="4578647" y="4123163"/>
              <a:ext cx="57517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Arial"/>
                  <a:cs typeface="Arial"/>
                </a:rPr>
                <a:t>Control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4578647" y="4353995"/>
              <a:ext cx="57517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Arial"/>
                  <a:cs typeface="Arial"/>
                </a:rPr>
                <a:t>L-Arg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4578647" y="4583461"/>
              <a:ext cx="57517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Arial"/>
                  <a:cs typeface="Arial"/>
                </a:rPr>
                <a:t>L-Cit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4578648" y="4788111"/>
              <a:ext cx="57517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Arial"/>
                  <a:cs typeface="Arial"/>
                </a:rPr>
                <a:t>LALC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3" name="正方形/長方形 2"/>
            <p:cNvSpPr/>
            <p:nvPr/>
          </p:nvSpPr>
          <p:spPr>
            <a:xfrm>
              <a:off x="4118285" y="4135737"/>
              <a:ext cx="1137561" cy="864000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/>
                <a:cs typeface="Arial"/>
              </a:endParaRPr>
            </a:p>
          </p:txBody>
        </p:sp>
      </p:grpSp>
      <p:grpSp>
        <p:nvGrpSpPr>
          <p:cNvPr id="14" name="図形グループ 13"/>
          <p:cNvGrpSpPr/>
          <p:nvPr/>
        </p:nvGrpSpPr>
        <p:grpSpPr>
          <a:xfrm>
            <a:off x="4270685" y="7622386"/>
            <a:ext cx="1137561" cy="895780"/>
            <a:chOff x="4118285" y="4123163"/>
            <a:chExt cx="1137561" cy="895780"/>
          </a:xfrm>
        </p:grpSpPr>
        <p:sp>
          <p:nvSpPr>
            <p:cNvPr id="15" name="テキスト ボックス 14"/>
            <p:cNvSpPr txBox="1"/>
            <p:nvPr/>
          </p:nvSpPr>
          <p:spPr>
            <a:xfrm>
              <a:off x="4578647" y="4123163"/>
              <a:ext cx="57517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Arial"/>
                  <a:cs typeface="Arial"/>
                </a:rPr>
                <a:t>Control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4578647" y="4353995"/>
              <a:ext cx="57517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Arial"/>
                  <a:cs typeface="Arial"/>
                </a:rPr>
                <a:t>L-Arg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4578647" y="4583461"/>
              <a:ext cx="57517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Arial"/>
                  <a:cs typeface="Arial"/>
                </a:rPr>
                <a:t>L-Cit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4578648" y="4788111"/>
              <a:ext cx="57517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Arial"/>
                  <a:cs typeface="Arial"/>
                </a:rPr>
                <a:t>LALC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9" name="正方形/長方形 18"/>
            <p:cNvSpPr/>
            <p:nvPr/>
          </p:nvSpPr>
          <p:spPr>
            <a:xfrm>
              <a:off x="4118285" y="4135737"/>
              <a:ext cx="1137561" cy="864000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4922675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35</TotalTime>
  <Words>33</Words>
  <Application>Microsoft Macintosh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スライド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eda</dc:creator>
  <cp:lastModifiedBy>林 登志雄</cp:lastModifiedBy>
  <cp:revision>89</cp:revision>
  <cp:lastPrinted>2017-12-27T01:36:15Z</cp:lastPrinted>
  <dcterms:created xsi:type="dcterms:W3CDTF">2018-01-17T04:18:27Z</dcterms:created>
  <dcterms:modified xsi:type="dcterms:W3CDTF">2018-01-17T04:20:52Z</dcterms:modified>
</cp:coreProperties>
</file>